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86" autoAdjust="0"/>
    <p:restoredTop sz="92276" autoAdjust="0"/>
  </p:normalViewPr>
  <p:slideViewPr>
    <p:cSldViewPr snapToGrid="0">
      <p:cViewPr varScale="1">
        <p:scale>
          <a:sx n="89" d="100"/>
          <a:sy n="89" d="100"/>
        </p:scale>
        <p:origin x="110" y="43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26" d="100"/>
        <a:sy n="12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EB08D0-07D1-4FCA-9739-7285C6712C70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540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73575"/>
            <a:ext cx="55054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A335A4-D22F-4220-A92B-B9BF61066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893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14B89B-1373-45F7-A89F-8A643980959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8604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3511E5-3772-40AB-872A-1A89D3A39A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1C81B7-40B7-4F8F-8BD0-0AA15256CA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7E7419-88CE-4A8D-AFE8-64D41CC9B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F2CE16-9BC8-4F91-A3A5-C1DD495FC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408440-F70F-4D83-B488-EA19E1705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13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9AAB0E-873E-4A72-8996-58325FD295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84F6C1-A7B2-4F5D-B642-FF6BF5A7CD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0FE7D9-E22E-40D9-993D-89DA005C0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05492E-C4F2-4A52-B644-48E44E0B8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18BC3-CA0C-4E54-A556-19EAF8C07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685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AEAE64-A6C8-4496-B54A-0785F62D7B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78FC39-6C3F-44A5-B707-7AF18D7805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27312E-C61F-4974-AC58-487210C60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8EFAC5-EB6C-4B2C-A45E-6D093B33E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E8DE9B-562E-493C-ABCF-5F33F6BAB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993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0A352-C5FD-4EFE-944E-2EB093206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F1879A-DFDB-4275-BE41-8E9D400804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18339-6E36-40A4-94EA-70E46566B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4C7E52-CD83-405B-B1B9-56EB7ADFB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61D67-D46A-4FA5-85DE-272A2736F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227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2B63FA-BF7E-48D1-A473-6813401A9A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392FB2-870A-44CB-A263-B50CFE5C6B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8D5B81-FC1C-49D2-8295-90E2A329D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79BDA-BF16-49F2-B87C-E36F090F5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82DAC-DC66-433B-9DF7-2C7D3D835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3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D86169-166F-4272-BF78-44F83EBFAC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8BD9F8-A684-47DB-BA93-37355A8B21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22F5B8-3ECF-4E9D-92B4-C8D86B407E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691DE8-EAA4-46E3-B2C6-94F3ECC8A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4C53AC-C969-412C-BCC5-60D911105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858094-6D92-4652-AE06-589C26D9E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729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5B880-588A-4020-B8FE-0B62388C8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3593CD-AA23-4D95-85E6-DA886FBB37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5D0097-71EC-4C6F-996B-F373F47939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94B055-36A4-409B-AE1D-E840E947F1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B0C06F-5F5C-4E04-98E7-E503EE9C01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72348E-D15A-4805-AC59-DF380BD0D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7D6FEA-50CF-461C-8DAA-13108FBD7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7D9578-86FE-4605-9AA9-2F25DF681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154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B75220-FA78-49F8-BB7E-88DBFAE92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8F14FE-9F66-4406-BDC9-8A24E54F7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5DB50D-4A3A-48F4-8168-6FA75F7D9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F240E0-E715-4EAB-BA52-D62CB52FB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666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029A0-4C99-4F26-9F6D-7E523132D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6A45C0-9E4A-4417-A8EB-A3F4D80FC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A12FE3-DF8E-4408-8DC5-D4E58F820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678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16730-0810-45BC-81DE-3E112FE3A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66836C-D5F3-4E66-AE6E-4BF6071335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A0F478-6AAE-40CD-B4C3-1A03642956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BB5C71-72D8-450D-9106-6D100C370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44DE36-FE5D-4DE2-B856-34296EA59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FFF802-6D2D-4874-8996-AED6F7255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33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8A712C-AABD-4E9C-AA78-64FCF0944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9F6720-053A-485B-9A96-670F80CA4C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3B7C13-84FE-4D57-9B51-EF0815E411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374A54-1B62-4720-BBDB-31B480768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F09770-65EF-429F-A76D-A65AD7860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A9DE4E-B379-4424-BED9-8B11ED688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566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E35207-D1FB-45E2-B788-63E502F344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502CA1-5EF6-4DDB-B55E-AF27B8C416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0CF55-47F0-4018-9AE4-B77803D66A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37B262-F7E5-4BE1-A642-7AC135EE39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A93D6C-2A45-4028-85C3-E7D94264AF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49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1BCE3A96-F021-2F8A-1968-2DC94BE84EDF}"/>
              </a:ext>
            </a:extLst>
          </p:cNvPr>
          <p:cNvGrpSpPr/>
          <p:nvPr/>
        </p:nvGrpSpPr>
        <p:grpSpPr>
          <a:xfrm>
            <a:off x="9235882" y="3307946"/>
            <a:ext cx="2475597" cy="2953916"/>
            <a:chOff x="301893" y="475084"/>
            <a:chExt cx="2475597" cy="295391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1A18CE4-39FC-7D99-05BD-A5B040392D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9000" contrast="-52000"/>
                      </a14:imgEffect>
                    </a14:imgLayer>
                  </a14:imgProps>
                </a:ext>
              </a:extLst>
            </a:blip>
            <a:srcRect l="13529" t="6887" r="13487" b="5485"/>
            <a:stretch/>
          </p:blipFill>
          <p:spPr>
            <a:xfrm>
              <a:off x="301893" y="752206"/>
              <a:ext cx="2475597" cy="2676794"/>
            </a:xfrm>
            <a:prstGeom prst="rect">
              <a:avLst/>
            </a:prstGeom>
            <a:ln>
              <a:noFill/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F7CC6AB-621E-0D5C-AF4F-C123E6EFDEB7}"/>
                </a:ext>
              </a:extLst>
            </p:cNvPr>
            <p:cNvSpPr txBox="1"/>
            <p:nvPr/>
          </p:nvSpPr>
          <p:spPr>
            <a:xfrm>
              <a:off x="1431594" y="475084"/>
              <a:ext cx="10019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SC62709</a:t>
              </a:r>
            </a:p>
          </p:txBody>
        </p:sp>
      </p:grpSp>
      <p:sp>
        <p:nvSpPr>
          <p:cNvPr id="18" name="Text Box 132">
            <a:extLst>
              <a:ext uri="{FF2B5EF4-FFF2-40B4-BE49-F238E27FC236}">
                <a16:creationId xmlns:a16="http://schemas.microsoft.com/office/drawing/2014/main" id="{386C1777-F5AC-44B7-2417-72DFD6C53C40}"/>
              </a:ext>
            </a:extLst>
          </p:cNvPr>
          <p:cNvSpPr txBox="1"/>
          <p:nvPr/>
        </p:nvSpPr>
        <p:spPr>
          <a:xfrm>
            <a:off x="4289525" y="-2427514"/>
            <a:ext cx="303319" cy="21759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8C5CE17-4912-0358-D3FA-1F6CB9CEA965}"/>
              </a:ext>
            </a:extLst>
          </p:cNvPr>
          <p:cNvGrpSpPr/>
          <p:nvPr/>
        </p:nvGrpSpPr>
        <p:grpSpPr>
          <a:xfrm>
            <a:off x="6771718" y="3307946"/>
            <a:ext cx="2288989" cy="1709995"/>
            <a:chOff x="2946818" y="466201"/>
            <a:chExt cx="2288989" cy="1709995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DA64ECC7-C71C-4F1A-8B7A-AE9EA22CF7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12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37" t="23911" r="12316" b="22234"/>
            <a:stretch/>
          </p:blipFill>
          <p:spPr>
            <a:xfrm>
              <a:off x="2946818" y="696918"/>
              <a:ext cx="2288989" cy="1479278"/>
            </a:xfrm>
            <a:prstGeom prst="rect">
              <a:avLst/>
            </a:prstGeom>
            <a:ln>
              <a:noFill/>
            </a:ln>
          </p:spPr>
        </p:pic>
        <p:sp>
          <p:nvSpPr>
            <p:cNvPr id="13" name="Text Box 855">
              <a:extLst>
                <a:ext uri="{FF2B5EF4-FFF2-40B4-BE49-F238E27FC236}">
                  <a16:creationId xmlns:a16="http://schemas.microsoft.com/office/drawing/2014/main" id="{B46AC21B-3732-6E5A-8D67-FD4ABCEEFEC2}"/>
                </a:ext>
              </a:extLst>
            </p:cNvPr>
            <p:cNvSpPr txBox="1"/>
            <p:nvPr/>
          </p:nvSpPr>
          <p:spPr>
            <a:xfrm>
              <a:off x="3600083" y="466201"/>
              <a:ext cx="1043916" cy="282373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NSC35676</a:t>
              </a:r>
              <a:endPara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17DD6E4-9C46-70B5-F162-794E22E8E534}"/>
              </a:ext>
            </a:extLst>
          </p:cNvPr>
          <p:cNvGrpSpPr/>
          <p:nvPr/>
        </p:nvGrpSpPr>
        <p:grpSpPr>
          <a:xfrm>
            <a:off x="1122476" y="3262273"/>
            <a:ext cx="2729875" cy="2341884"/>
            <a:chOff x="5729733" y="287378"/>
            <a:chExt cx="2729875" cy="2341884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E241C83-5AF6-9208-9DFC-E4B589A38C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7000"/>
                      </a14:imgEffect>
                    </a14:imgLayer>
                  </a14:imgProps>
                </a:ext>
              </a:extLst>
            </a:blip>
            <a:srcRect l="1484" t="7015" r="5038" b="8532"/>
            <a:stretch/>
          </p:blipFill>
          <p:spPr>
            <a:xfrm>
              <a:off x="5729733" y="408211"/>
              <a:ext cx="2729875" cy="2221051"/>
            </a:xfrm>
            <a:prstGeom prst="rect">
              <a:avLst/>
            </a:prstGeom>
            <a:ln>
              <a:noFill/>
            </a:ln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D3330E9-B4BB-D33C-9AE8-37FE7572C7B7}"/>
                </a:ext>
              </a:extLst>
            </p:cNvPr>
            <p:cNvSpPr txBox="1"/>
            <p:nvPr/>
          </p:nvSpPr>
          <p:spPr>
            <a:xfrm>
              <a:off x="6397548" y="287378"/>
              <a:ext cx="10439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SC133100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12197D2-82F7-5D13-C548-1B0622ACFCFE}"/>
              </a:ext>
            </a:extLst>
          </p:cNvPr>
          <p:cNvGrpSpPr/>
          <p:nvPr/>
        </p:nvGrpSpPr>
        <p:grpSpPr>
          <a:xfrm>
            <a:off x="3958427" y="3249289"/>
            <a:ext cx="2418288" cy="2416741"/>
            <a:chOff x="8895447" y="462918"/>
            <a:chExt cx="2418288" cy="2416741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43C09EA2-90E2-E1D1-49E5-F9C2F63926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brightnessContrast bright="13000"/>
                      </a14:imgEffect>
                    </a14:imgLayer>
                  </a14:imgProps>
                </a:ext>
              </a:extLst>
            </a:blip>
            <a:srcRect l="4152" t="7291" r="7669" b="2778"/>
            <a:stretch/>
          </p:blipFill>
          <p:spPr>
            <a:xfrm>
              <a:off x="8895447" y="658608"/>
              <a:ext cx="2418288" cy="2221051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2400339-72AE-9625-8CE2-39F91F8CC77C}"/>
                </a:ext>
              </a:extLst>
            </p:cNvPr>
            <p:cNvSpPr txBox="1"/>
            <p:nvPr/>
          </p:nvSpPr>
          <p:spPr>
            <a:xfrm>
              <a:off x="9979710" y="462918"/>
              <a:ext cx="9693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SC87511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265FE0F-AF5B-A2FB-250D-645019FD2A4C}"/>
              </a:ext>
            </a:extLst>
          </p:cNvPr>
          <p:cNvGrpSpPr/>
          <p:nvPr/>
        </p:nvGrpSpPr>
        <p:grpSpPr>
          <a:xfrm>
            <a:off x="1265946" y="213440"/>
            <a:ext cx="2807352" cy="2638976"/>
            <a:chOff x="139466" y="4037322"/>
            <a:chExt cx="2807352" cy="263897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5F478FF-1D20-F2C2-12BB-8E1BFD3118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  <a14:imgEffect>
                        <a14:brightnessContrast bright="6000"/>
                      </a14:imgEffect>
                    </a14:imgLayer>
                  </a14:imgProps>
                </a:ext>
              </a:extLst>
            </a:blip>
            <a:srcRect l="5354" t="6618" r="6958" b="5920"/>
            <a:stretch/>
          </p:blipFill>
          <p:spPr>
            <a:xfrm>
              <a:off x="139466" y="4178520"/>
              <a:ext cx="2807352" cy="2497778"/>
            </a:xfrm>
            <a:prstGeom prst="rect">
              <a:avLst/>
            </a:prstGeom>
            <a:ln>
              <a:noFill/>
            </a:ln>
          </p:spPr>
        </p:pic>
        <p:sp>
          <p:nvSpPr>
            <p:cNvPr id="3" name="Text Box 1">
              <a:extLst>
                <a:ext uri="{FF2B5EF4-FFF2-40B4-BE49-F238E27FC236}">
                  <a16:creationId xmlns:a16="http://schemas.microsoft.com/office/drawing/2014/main" id="{7E2CA85F-99F4-2F19-683D-D3F243917A25}"/>
                </a:ext>
              </a:extLst>
            </p:cNvPr>
            <p:cNvSpPr txBox="1"/>
            <p:nvPr/>
          </p:nvSpPr>
          <p:spPr>
            <a:xfrm>
              <a:off x="1124216" y="4037322"/>
              <a:ext cx="1055914" cy="28239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NSC177383</a:t>
              </a:r>
              <a:endPara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F95FD01D-1BF9-FFB4-CE1F-A9EFB15C0AFE}"/>
              </a:ext>
            </a:extLst>
          </p:cNvPr>
          <p:cNvGrpSpPr/>
          <p:nvPr/>
        </p:nvGrpSpPr>
        <p:grpSpPr>
          <a:xfrm>
            <a:off x="7460280" y="252830"/>
            <a:ext cx="2895041" cy="2560878"/>
            <a:chOff x="3200959" y="4218341"/>
            <a:chExt cx="2895041" cy="256087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681F859-FF0C-766A-6DA0-3C0196182B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50000"/>
                      </a14:imgEffect>
                      <a14:imgEffect>
                        <a14:brightnessContrast bright="11000"/>
                      </a14:imgEffect>
                    </a14:imgLayer>
                  </a14:imgProps>
                </a:ext>
              </a:extLst>
            </a:blip>
            <a:srcRect l="7455" t="12862" r="9509" b="5372"/>
            <a:stretch/>
          </p:blipFill>
          <p:spPr>
            <a:xfrm>
              <a:off x="3200959" y="4349146"/>
              <a:ext cx="2895041" cy="2430073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6BD0EC9-4B86-2439-195F-34AE2C8FB8A3}"/>
                </a:ext>
              </a:extLst>
            </p:cNvPr>
            <p:cNvSpPr txBox="1"/>
            <p:nvPr/>
          </p:nvSpPr>
          <p:spPr>
            <a:xfrm>
              <a:off x="4280346" y="4218341"/>
              <a:ext cx="8926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SC56410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3855B163-1627-66DF-2118-68C2F4C22F00}"/>
              </a:ext>
            </a:extLst>
          </p:cNvPr>
          <p:cNvGrpSpPr/>
          <p:nvPr/>
        </p:nvGrpSpPr>
        <p:grpSpPr>
          <a:xfrm>
            <a:off x="4289525" y="213440"/>
            <a:ext cx="2895041" cy="2508853"/>
            <a:chOff x="8291759" y="3675519"/>
            <a:chExt cx="2895041" cy="2508853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1CAF1D5-17DA-4EC1-6EE3-B20ED4215D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50000"/>
                      </a14:imgEffect>
                      <a14:imgEffect>
                        <a14:brightnessContrast bright="16000"/>
                      </a14:imgEffect>
                    </a14:imgLayer>
                  </a14:imgProps>
                </a:ext>
              </a:extLst>
            </a:blip>
            <a:srcRect l="2356" t="7929" r="7644" b="9929"/>
            <a:stretch/>
          </p:blipFill>
          <p:spPr>
            <a:xfrm>
              <a:off x="8291759" y="3806324"/>
              <a:ext cx="2895041" cy="237804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73C7C2E-F54C-2701-E89D-A18D01CD7966}"/>
                </a:ext>
              </a:extLst>
            </p:cNvPr>
            <p:cNvSpPr txBox="1"/>
            <p:nvPr/>
          </p:nvSpPr>
          <p:spPr>
            <a:xfrm>
              <a:off x="9032079" y="3675519"/>
              <a:ext cx="11854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SC145612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A567E37D-FC87-31E9-8641-19FFBD27E225}"/>
              </a:ext>
            </a:extLst>
          </p:cNvPr>
          <p:cNvSpPr txBox="1"/>
          <p:nvPr/>
        </p:nvSpPr>
        <p:spPr>
          <a:xfrm>
            <a:off x="985987" y="6098030"/>
            <a:ext cx="6198579" cy="4053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3 Fig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llustrations of the chemical structures of the inhibitors fo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iMT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enzyme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8276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0</TotalTime>
  <Words>24</Words>
  <Application>Microsoft Office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a, Mukthar</dc:creator>
  <cp:lastModifiedBy>Witola, William Harold</cp:lastModifiedBy>
  <cp:revision>205</cp:revision>
  <cp:lastPrinted>2024-01-22T18:41:37Z</cp:lastPrinted>
  <dcterms:created xsi:type="dcterms:W3CDTF">2024-01-18T19:24:34Z</dcterms:created>
  <dcterms:modified xsi:type="dcterms:W3CDTF">2024-08-22T01:46:15Z</dcterms:modified>
</cp:coreProperties>
</file>